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66" r:id="rId2"/>
    <p:sldId id="265" r:id="rId3"/>
    <p:sldId id="264" r:id="rId4"/>
    <p:sldId id="263" r:id="rId5"/>
    <p:sldId id="267" r:id="rId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0" d="100"/>
          <a:sy n="100" d="100"/>
        </p:scale>
        <p:origin x="1836" y="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16/06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202801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342339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0400269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533442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9155491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6/06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6/06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6/06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6/06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6/06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6/06/2020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6/06/2020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6/06/2020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6/06/2020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6/06/2020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6/06/2020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16/06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1520" y="5910371"/>
            <a:ext cx="799288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Moede et al (2020) Diabetologia DOI 10.1007/s00125-020-05196-3 </a:t>
            </a:r>
          </a:p>
          <a:p>
            <a:r>
              <a:rPr lang="en-GB" sz="1200" dirty="0"/>
              <a:t>© The Authors 2020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Simplified scheme of stimulus–secretion-coupling pathways in the pancreatic beta cell and possible interaction points for alpha cell-derived paracrine signals</a:t>
            </a:r>
            <a:endParaRPr lang="en-GB" sz="2000" b="1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C49B3C00-6F04-434A-8070-5257F258588E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15" t="515"/>
          <a:stretch/>
        </p:blipFill>
        <p:spPr>
          <a:xfrm>
            <a:off x="1691680" y="1268760"/>
            <a:ext cx="5645465" cy="45847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798511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Schematic representation of the post-translational processing of proglucagon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C51EB052-1D1D-44E3-953B-F02DBD50637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72469" y="936105"/>
            <a:ext cx="5951860" cy="4941167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EE964FEB-F8AD-46C8-8026-3B60B93C15DD}"/>
              </a:ext>
            </a:extLst>
          </p:cNvPr>
          <p:cNvSpPr txBox="1"/>
          <p:nvPr/>
        </p:nvSpPr>
        <p:spPr>
          <a:xfrm>
            <a:off x="251520" y="5910371"/>
            <a:ext cx="799288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Moede et al (2020) Diabetologia DOI 10.1007/s00125-020-05196-3 </a:t>
            </a:r>
          </a:p>
          <a:p>
            <a:r>
              <a:rPr lang="en-GB" sz="1200" dirty="0"/>
              <a:t>© The Authors 2020</a:t>
            </a:r>
          </a:p>
        </p:txBody>
      </p:sp>
    </p:spTree>
    <p:extLst>
      <p:ext uri="{BB962C8B-B14F-4D97-AF65-F5344CB8AC3E}">
        <p14:creationId xmlns:p14="http://schemas.microsoft.com/office/powerpoint/2010/main" val="6291821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Schematic representation of the structure (a, b) and vasculature (c, d) of rodent and human islets</a:t>
            </a:r>
            <a:endParaRPr lang="en-GB" sz="2000" b="1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A452C4A-53BC-4B60-8A24-3A8489ECB949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162" t="1169" r="1380" b="4833"/>
          <a:stretch/>
        </p:blipFill>
        <p:spPr>
          <a:xfrm>
            <a:off x="2267745" y="1110612"/>
            <a:ext cx="4968552" cy="476666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927B7C47-614D-4CE1-9848-DFF2CDE0AADF}"/>
              </a:ext>
            </a:extLst>
          </p:cNvPr>
          <p:cNvSpPr txBox="1"/>
          <p:nvPr/>
        </p:nvSpPr>
        <p:spPr>
          <a:xfrm>
            <a:off x="251520" y="5910371"/>
            <a:ext cx="799288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Moede et al (2020) Diabetologia DOI 10.1007/s00125-020-05196-3 </a:t>
            </a:r>
          </a:p>
          <a:p>
            <a:r>
              <a:rPr lang="en-GB" sz="1200" dirty="0"/>
              <a:t>© The Authors 2020</a:t>
            </a:r>
          </a:p>
        </p:txBody>
      </p:sp>
    </p:spTree>
    <p:extLst>
      <p:ext uri="{BB962C8B-B14F-4D97-AF65-F5344CB8AC3E}">
        <p14:creationId xmlns:p14="http://schemas.microsoft.com/office/powerpoint/2010/main" val="174939850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Schematic representation of the difference in cholinergic signalling in mouse and human islets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A762663-1645-40D7-8ADA-3C4F3DE28A9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95736" y="1098600"/>
            <a:ext cx="4921518" cy="4706664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13D644B4-FB6F-4A20-B483-79760A95CAB2}"/>
              </a:ext>
            </a:extLst>
          </p:cNvPr>
          <p:cNvSpPr txBox="1"/>
          <p:nvPr/>
        </p:nvSpPr>
        <p:spPr>
          <a:xfrm>
            <a:off x="251520" y="5910371"/>
            <a:ext cx="799288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Moede et al (2020) Diabetologia DOI 10.1007/s00125-020-05196-3 </a:t>
            </a:r>
          </a:p>
          <a:p>
            <a:r>
              <a:rPr lang="en-GB" sz="1200" dirty="0"/>
              <a:t>© The Authors 2020</a:t>
            </a:r>
          </a:p>
        </p:txBody>
      </p:sp>
    </p:spTree>
    <p:extLst>
      <p:ext uri="{BB962C8B-B14F-4D97-AF65-F5344CB8AC3E}">
        <p14:creationId xmlns:p14="http://schemas.microsoft.com/office/powerpoint/2010/main" val="116517286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51520" y="190381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Islet transplantation into the anterior chamber of the eye (ACE) as a tool to study human islet physiology/pathology in vivo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44E11C65-BE01-4123-80F7-E4AE3210883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19872" y="836711"/>
            <a:ext cx="2736304" cy="5296547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335A3540-6B0D-4B5A-BA58-22124FC74BA5}"/>
              </a:ext>
            </a:extLst>
          </p:cNvPr>
          <p:cNvSpPr txBox="1"/>
          <p:nvPr/>
        </p:nvSpPr>
        <p:spPr>
          <a:xfrm>
            <a:off x="251520" y="5910371"/>
            <a:ext cx="799288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Moede et al (2020) Diabetologia DOI 10.1007/s00125-020-05196-3 </a:t>
            </a:r>
          </a:p>
          <a:p>
            <a:r>
              <a:rPr lang="en-GB" sz="1200" dirty="0"/>
              <a:t>© The Authors 2020</a:t>
            </a:r>
          </a:p>
        </p:txBody>
      </p:sp>
    </p:spTree>
    <p:extLst>
      <p:ext uri="{BB962C8B-B14F-4D97-AF65-F5344CB8AC3E}">
        <p14:creationId xmlns:p14="http://schemas.microsoft.com/office/powerpoint/2010/main" val="19095204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9</TotalTime>
  <Words>168</Words>
  <Application>Microsoft Office PowerPoint</Application>
  <PresentationFormat>On-screen Show (4:3)</PresentationFormat>
  <Paragraphs>25</Paragraphs>
  <Slides>5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8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Jose Ruffino</cp:lastModifiedBy>
  <cp:revision>46</cp:revision>
  <dcterms:created xsi:type="dcterms:W3CDTF">2016-06-15T12:53:43Z</dcterms:created>
  <dcterms:modified xsi:type="dcterms:W3CDTF">2020-06-16T14:15:55Z</dcterms:modified>
</cp:coreProperties>
</file>